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8" d="100"/>
          <a:sy n="68" d="100"/>
        </p:scale>
        <p:origin x="-3352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9356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714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268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719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973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438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137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585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406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279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504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0E320A-CB8E-0A43-B8EA-3A81B3EBE8BF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BCCCB-FADC-F246-8EAC-9AF29521A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65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57448" y="744444"/>
            <a:ext cx="2913615" cy="2910013"/>
            <a:chOff x="3668873" y="372941"/>
            <a:chExt cx="2913615" cy="2910013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68873" y="372941"/>
              <a:ext cx="2913615" cy="2910013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4196163" y="562577"/>
              <a:ext cx="5054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Basal 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014839" y="2162246"/>
              <a:ext cx="14418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cs typeface="Arial"/>
                </a:rPr>
                <a:t>CAIX mRNA expression</a:t>
              </a:r>
              <a:endParaRPr lang="en-US" sz="900" dirty="0">
                <a:latin typeface="Arial"/>
                <a:cs typeface="Arial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3523260" y="815380"/>
            <a:ext cx="2965650" cy="2839077"/>
            <a:chOff x="1903906" y="1045314"/>
            <a:chExt cx="2965650" cy="2885987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03906" y="1045314"/>
              <a:ext cx="2965650" cy="2885987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2492429" y="1187058"/>
              <a:ext cx="5267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HER2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265580" y="2844609"/>
              <a:ext cx="1409780" cy="2346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cs typeface="Arial"/>
                </a:rPr>
                <a:t>CAIX mRNA expression</a:t>
              </a:r>
              <a:endParaRPr lang="en-US" sz="900" dirty="0">
                <a:latin typeface="Arial"/>
                <a:cs typeface="Arial"/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496848" y="4048235"/>
            <a:ext cx="3045788" cy="2976813"/>
            <a:chOff x="2059613" y="3406590"/>
            <a:chExt cx="3045788" cy="2976813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059613" y="3406590"/>
              <a:ext cx="3045788" cy="2976813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2793713" y="3612617"/>
              <a:ext cx="7489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Luminal A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462714" y="5278984"/>
              <a:ext cx="14097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cs typeface="Arial"/>
                </a:rPr>
                <a:t>CAIX mRNA expression</a:t>
              </a:r>
              <a:endParaRPr lang="en-US" sz="900" dirty="0">
                <a:latin typeface="Arial"/>
                <a:cs typeface="Arial"/>
              </a:endParaRP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3475796" y="3987184"/>
            <a:ext cx="3041705" cy="3067204"/>
            <a:chOff x="5676979" y="3585031"/>
            <a:chExt cx="3041705" cy="3067204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676979" y="3585031"/>
              <a:ext cx="3041705" cy="3067204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6269061" y="3864962"/>
              <a:ext cx="7549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Luminal B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066399" y="5547724"/>
              <a:ext cx="14097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cs typeface="Arial"/>
                </a:rPr>
                <a:t>CAIX mRNA expression</a:t>
              </a:r>
              <a:endParaRPr lang="en-US" sz="900" dirty="0">
                <a:latin typeface="Arial"/>
                <a:cs typeface="Arial"/>
              </a:endParaRPr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448557" y="491604"/>
            <a:ext cx="3770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/>
                <a:cs typeface="Arial"/>
              </a:rPr>
              <a:t>A</a:t>
            </a:r>
            <a:endParaRPr lang="en-US" sz="20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452892" y="491604"/>
            <a:ext cx="4320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/>
                <a:cs typeface="Arial"/>
              </a:rPr>
              <a:t>B</a:t>
            </a:r>
            <a:endParaRPr lang="en-US" sz="20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471063" y="3787129"/>
            <a:ext cx="3601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/>
                <a:cs typeface="Arial"/>
              </a:rPr>
              <a:t>D</a:t>
            </a:r>
            <a:endParaRPr lang="en-US" sz="2000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77389" y="3787129"/>
            <a:ext cx="3601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/>
                <a:cs typeface="Arial"/>
              </a:rPr>
              <a:t>C</a:t>
            </a:r>
            <a:endParaRPr lang="en-US" sz="2000" dirty="0">
              <a:latin typeface="Arial"/>
              <a:cs typeface="Arial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67830" y="8731220"/>
            <a:ext cx="8772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1 Fig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681262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Frost</dc:creator>
  <cp:lastModifiedBy>Susan Frost</cp:lastModifiedBy>
  <cp:revision>1</cp:revision>
  <dcterms:created xsi:type="dcterms:W3CDTF">2018-06-13T18:12:05Z</dcterms:created>
  <dcterms:modified xsi:type="dcterms:W3CDTF">2018-06-13T18:13:01Z</dcterms:modified>
</cp:coreProperties>
</file>